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086" y="-4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44D66B-7F32-4339-AFFA-F10041DA106D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CEF5C5-45BF-4608-B1B9-500EC09C7018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" name="直線矢印コネクタ 20"/>
          <p:cNvCxnSpPr/>
          <p:nvPr/>
        </p:nvCxnSpPr>
        <p:spPr>
          <a:xfrm>
            <a:off x="4572000" y="980728"/>
            <a:ext cx="0" cy="111600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/>
          <p:cNvSpPr txBox="1"/>
          <p:nvPr/>
        </p:nvSpPr>
        <p:spPr>
          <a:xfrm>
            <a:off x="2771800" y="44624"/>
            <a:ext cx="36559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CONSORT 2013 Flow Diagram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3312144" y="548680"/>
            <a:ext cx="2520280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ssessed for eligibility (n=97)</a:t>
            </a:r>
            <a:endParaRPr kumimoji="1" lang="ja-JP" alt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3312144" y="1340768"/>
            <a:ext cx="2556000" cy="43204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Randomized (n=96)</a:t>
            </a:r>
            <a:endParaRPr kumimoji="1" lang="ja-JP" alt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323528" y="2708920"/>
            <a:ext cx="3600400" cy="5760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llocated to </a:t>
            </a:r>
          </a:p>
          <a:p>
            <a:pPr algn="ctr"/>
            <a:r>
              <a:rPr kumimoji="1" lang="en-US" altLang="ja-JP" sz="14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vildagliptin</a:t>
            </a:r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additional (n=48)</a:t>
            </a:r>
            <a:endParaRPr kumimoji="1" lang="ja-JP" alt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5220072" y="2708920"/>
            <a:ext cx="3600000" cy="5760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llocated to </a:t>
            </a:r>
          </a:p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high-</a:t>
            </a:r>
            <a:r>
              <a:rPr kumimoji="1" lang="en-US" altLang="ja-JP" sz="14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etformin</a:t>
            </a:r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(n=48)</a:t>
            </a:r>
            <a:endParaRPr kumimoji="1" lang="ja-JP" alt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323528" y="3717112"/>
            <a:ext cx="3600000" cy="79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ost to follow-up (n=2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</a:t>
            </a:r>
            <a:endParaRPr lang="en-US" altLang="ja-JP" sz="14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ja-JP" alt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　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ja-JP" alt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・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Interruption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mbulatory (n=2)</a:t>
            </a:r>
            <a:endParaRPr lang="en-US" altLang="ja-JP" sz="14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endParaRPr lang="en-US" altLang="ja-JP" sz="14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5220072" y="3717032"/>
            <a:ext cx="3600000" cy="7920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ost to follow-up (n=5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</a:t>
            </a:r>
            <a:endParaRPr lang="en-US" altLang="ja-JP" sz="14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r>
              <a:rPr kumimoji="1" lang="ja-JP" alt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　  ・</a:t>
            </a:r>
            <a:r>
              <a:rPr lang="en-US" altLang="ja-JP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Interruption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mbulatory (n=3)</a:t>
            </a:r>
            <a:endParaRPr kumimoji="1" lang="en-US" altLang="ja-JP" sz="14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r>
              <a:rPr lang="ja-JP" alt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  　・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ide effects (n=2)  </a:t>
            </a:r>
            <a:endParaRPr kumimoji="1" lang="en-US" altLang="ja-JP" sz="14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323528" y="5157192"/>
            <a:ext cx="3600400" cy="5760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46 completed 12 week follow-up observation</a:t>
            </a:r>
            <a:endParaRPr kumimoji="1" lang="ja-JP" alt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5219672" y="5157192"/>
            <a:ext cx="3600400" cy="5760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43 completed 12 week follow-up observation</a:t>
            </a:r>
            <a:endParaRPr kumimoji="1" lang="ja-JP" alt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323528" y="5949280"/>
            <a:ext cx="3600400" cy="5760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48 were included in the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Intention-to-treat population</a:t>
            </a:r>
            <a:endParaRPr kumimoji="1" lang="ja-JP" alt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5219672" y="5949280"/>
            <a:ext cx="3600400" cy="5760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48 were included in the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Intention-to-treat population</a:t>
            </a:r>
            <a:endParaRPr kumimoji="1" lang="ja-JP" alt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角丸四角形 15"/>
          <p:cNvSpPr/>
          <p:nvPr/>
        </p:nvSpPr>
        <p:spPr>
          <a:xfrm>
            <a:off x="755576" y="548680"/>
            <a:ext cx="1800200" cy="504056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 smtClean="0">
                <a:solidFill>
                  <a:schemeClr val="tx2"/>
                </a:solidFill>
                <a:latin typeface="Times New Roman" pitchFamily="18" charset="0"/>
                <a:cs typeface="Times New Roman" pitchFamily="18" charset="0"/>
              </a:rPr>
              <a:t>Enrollment</a:t>
            </a:r>
            <a:endParaRPr kumimoji="1" lang="ja-JP" altLang="en-US" b="1" dirty="0">
              <a:solidFill>
                <a:schemeClr val="tx2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角丸四角形 16"/>
          <p:cNvSpPr/>
          <p:nvPr/>
        </p:nvSpPr>
        <p:spPr>
          <a:xfrm>
            <a:off x="3707904" y="2420888"/>
            <a:ext cx="1800200" cy="504056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 smtClean="0">
                <a:solidFill>
                  <a:schemeClr val="tx2"/>
                </a:solidFill>
                <a:latin typeface="Times New Roman" pitchFamily="18" charset="0"/>
                <a:cs typeface="Times New Roman" pitchFamily="18" charset="0"/>
              </a:rPr>
              <a:t>Allocation</a:t>
            </a:r>
            <a:endParaRPr kumimoji="1" lang="ja-JP" altLang="en-US" b="1" dirty="0">
              <a:solidFill>
                <a:schemeClr val="tx2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角丸四角形 17"/>
          <p:cNvSpPr/>
          <p:nvPr/>
        </p:nvSpPr>
        <p:spPr>
          <a:xfrm>
            <a:off x="3707904" y="3356992"/>
            <a:ext cx="1800200" cy="504056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 smtClean="0">
                <a:solidFill>
                  <a:schemeClr val="tx2"/>
                </a:solidFill>
                <a:latin typeface="Times New Roman" pitchFamily="18" charset="0"/>
                <a:cs typeface="Times New Roman" pitchFamily="18" charset="0"/>
              </a:rPr>
              <a:t>Follow-Up</a:t>
            </a:r>
            <a:endParaRPr kumimoji="1" lang="ja-JP" altLang="en-US" b="1" dirty="0">
              <a:solidFill>
                <a:schemeClr val="tx2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角丸四角形 18"/>
          <p:cNvSpPr/>
          <p:nvPr/>
        </p:nvSpPr>
        <p:spPr>
          <a:xfrm>
            <a:off x="3707904" y="4725144"/>
            <a:ext cx="1800200" cy="504056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 smtClean="0">
                <a:solidFill>
                  <a:schemeClr val="tx2"/>
                </a:solidFill>
                <a:latin typeface="Times New Roman" pitchFamily="18" charset="0"/>
                <a:cs typeface="Times New Roman" pitchFamily="18" charset="0"/>
              </a:rPr>
              <a:t>Analysis</a:t>
            </a:r>
            <a:endParaRPr kumimoji="1" lang="ja-JP" altLang="en-US" b="1" dirty="0">
              <a:solidFill>
                <a:schemeClr val="tx2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2" name="直線矢印コネクタ 21"/>
          <p:cNvCxnSpPr/>
          <p:nvPr/>
        </p:nvCxnSpPr>
        <p:spPr>
          <a:xfrm>
            <a:off x="2051720" y="3321032"/>
            <a:ext cx="0" cy="36000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/>
          <p:cNvCxnSpPr/>
          <p:nvPr/>
        </p:nvCxnSpPr>
        <p:spPr>
          <a:xfrm>
            <a:off x="7020272" y="3316088"/>
            <a:ext cx="0" cy="36000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/>
          <p:cNvCxnSpPr/>
          <p:nvPr/>
        </p:nvCxnSpPr>
        <p:spPr>
          <a:xfrm>
            <a:off x="7020272" y="4550064"/>
            <a:ext cx="0" cy="54000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/>
          <p:cNvCxnSpPr/>
          <p:nvPr/>
        </p:nvCxnSpPr>
        <p:spPr>
          <a:xfrm>
            <a:off x="2051720" y="4545184"/>
            <a:ext cx="0" cy="54000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>
            <a:off x="2051720" y="2132856"/>
            <a:ext cx="0" cy="50400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/>
          <p:cNvCxnSpPr/>
          <p:nvPr/>
        </p:nvCxnSpPr>
        <p:spPr>
          <a:xfrm>
            <a:off x="7020272" y="2132856"/>
            <a:ext cx="0" cy="50400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>
            <a:off x="2051720" y="2132856"/>
            <a:ext cx="496855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>
            <a:off x="4572000" y="1183104"/>
            <a:ext cx="1584000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正方形/長方形 32"/>
          <p:cNvSpPr/>
          <p:nvPr/>
        </p:nvSpPr>
        <p:spPr>
          <a:xfrm>
            <a:off x="6228184" y="980728"/>
            <a:ext cx="2556000" cy="43204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ut of criteria </a:t>
            </a:r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kumimoji="1"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1)</a:t>
            </a:r>
            <a:endParaRPr kumimoji="1" lang="ja-JP" alt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77</Words>
  <Application>Microsoft Office PowerPoint</Application>
  <PresentationFormat>画面に合わせる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itao</dc:creator>
  <cp:lastModifiedBy>kitao</cp:lastModifiedBy>
  <cp:revision>7</cp:revision>
  <dcterms:created xsi:type="dcterms:W3CDTF">2017-04-04T04:02:46Z</dcterms:created>
  <dcterms:modified xsi:type="dcterms:W3CDTF">2017-04-04T05:19:01Z</dcterms:modified>
</cp:coreProperties>
</file>